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8" r:id="rId5"/>
    <p:sldId id="259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3" d="100"/>
          <a:sy n="93" d="100"/>
        </p:scale>
        <p:origin x="2790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酒井　良子" userId="90edd1d5-b2ba-4aa8-8eb1-5bb9703cb036" providerId="ADAL" clId="{EC37E4E5-5585-4FE7-9F9C-8CAA9990845B}"/>
    <pc:docChg chg="modSld">
      <pc:chgData name="酒井　良子" userId="90edd1d5-b2ba-4aa8-8eb1-5bb9703cb036" providerId="ADAL" clId="{EC37E4E5-5585-4FE7-9F9C-8CAA9990845B}" dt="2021-01-19T00:18:07.806" v="37" actId="20577"/>
      <pc:docMkLst>
        <pc:docMk/>
      </pc:docMkLst>
      <pc:sldChg chg="addSp modSp">
        <pc:chgData name="酒井　良子" userId="90edd1d5-b2ba-4aa8-8eb1-5bb9703cb036" providerId="ADAL" clId="{EC37E4E5-5585-4FE7-9F9C-8CAA9990845B}" dt="2021-01-19T00:18:07.806" v="37" actId="20577"/>
        <pc:sldMkLst>
          <pc:docMk/>
          <pc:sldMk cId="3948386731" sldId="258"/>
        </pc:sldMkLst>
        <pc:spChg chg="mod">
          <ac:chgData name="酒井　良子" userId="90edd1d5-b2ba-4aa8-8eb1-5bb9703cb036" providerId="ADAL" clId="{EC37E4E5-5585-4FE7-9F9C-8CAA9990845B}" dt="2021-01-19T00:11:11.527" v="0" actId="207"/>
          <ac:spMkLst>
            <pc:docMk/>
            <pc:sldMk cId="3948386731" sldId="258"/>
            <ac:spMk id="39" creationId="{00000000-0000-0000-0000-000000000000}"/>
          </ac:spMkLst>
        </pc:spChg>
        <pc:spChg chg="mod">
          <ac:chgData name="酒井　良子" userId="90edd1d5-b2ba-4aa8-8eb1-5bb9703cb036" providerId="ADAL" clId="{EC37E4E5-5585-4FE7-9F9C-8CAA9990845B}" dt="2021-01-19T00:18:04.431" v="35" actId="20577"/>
          <ac:spMkLst>
            <pc:docMk/>
            <pc:sldMk cId="3948386731" sldId="258"/>
            <ac:spMk id="42" creationId="{00000000-0000-0000-0000-000000000000}"/>
          </ac:spMkLst>
        </pc:spChg>
        <pc:spChg chg="mod">
          <ac:chgData name="酒井　良子" userId="90edd1d5-b2ba-4aa8-8eb1-5bb9703cb036" providerId="ADAL" clId="{EC37E4E5-5585-4FE7-9F9C-8CAA9990845B}" dt="2021-01-19T00:11:21.310" v="2" actId="207"/>
          <ac:spMkLst>
            <pc:docMk/>
            <pc:sldMk cId="3948386731" sldId="258"/>
            <ac:spMk id="63" creationId="{00000000-0000-0000-0000-000000000000}"/>
          </ac:spMkLst>
        </pc:spChg>
        <pc:spChg chg="mod">
          <ac:chgData name="酒井　良子" userId="90edd1d5-b2ba-4aa8-8eb1-5bb9703cb036" providerId="ADAL" clId="{EC37E4E5-5585-4FE7-9F9C-8CAA9990845B}" dt="2021-01-19T00:17:52.627" v="29" actId="20577"/>
          <ac:spMkLst>
            <pc:docMk/>
            <pc:sldMk cId="3948386731" sldId="258"/>
            <ac:spMk id="91" creationId="{C8B4FDA8-6844-4CCD-B089-337269D08768}"/>
          </ac:spMkLst>
        </pc:spChg>
        <pc:spChg chg="mod">
          <ac:chgData name="酒井　良子" userId="90edd1d5-b2ba-4aa8-8eb1-5bb9703cb036" providerId="ADAL" clId="{EC37E4E5-5585-4FE7-9F9C-8CAA9990845B}" dt="2021-01-19T00:17:56.771" v="31" actId="20577"/>
          <ac:spMkLst>
            <pc:docMk/>
            <pc:sldMk cId="3948386731" sldId="258"/>
            <ac:spMk id="110" creationId="{8B02FEC0-03FC-48A3-BAE7-D5052FFF9E44}"/>
          </ac:spMkLst>
        </pc:spChg>
        <pc:spChg chg="mod">
          <ac:chgData name="酒井　良子" userId="90edd1d5-b2ba-4aa8-8eb1-5bb9703cb036" providerId="ADAL" clId="{EC37E4E5-5585-4FE7-9F9C-8CAA9990845B}" dt="2021-01-19T00:18:07.806" v="37" actId="20577"/>
          <ac:spMkLst>
            <pc:docMk/>
            <pc:sldMk cId="3948386731" sldId="258"/>
            <ac:spMk id="130" creationId="{5BF88E4F-608C-41A6-9ABA-D398D78CBE2F}"/>
          </ac:spMkLst>
        </pc:spChg>
        <pc:spChg chg="mod">
          <ac:chgData name="酒井　良子" userId="90edd1d5-b2ba-4aa8-8eb1-5bb9703cb036" providerId="ADAL" clId="{EC37E4E5-5585-4FE7-9F9C-8CAA9990845B}" dt="2021-01-19T00:18:00.425" v="33" actId="20577"/>
          <ac:spMkLst>
            <pc:docMk/>
            <pc:sldMk cId="3948386731" sldId="258"/>
            <ac:spMk id="170" creationId="{9A216167-E06B-4957-A667-ECCEF338D0FA}"/>
          </ac:spMkLst>
        </pc:spChg>
        <pc:grpChg chg="add mod">
          <ac:chgData name="酒井　良子" userId="90edd1d5-b2ba-4aa8-8eb1-5bb9703cb036" providerId="ADAL" clId="{EC37E4E5-5585-4FE7-9F9C-8CAA9990845B}" dt="2021-01-19T00:16:35.767" v="12" actId="1076"/>
          <ac:grpSpMkLst>
            <pc:docMk/>
            <pc:sldMk cId="3948386731" sldId="258"/>
            <ac:grpSpMk id="3" creationId="{1EA2F120-9A0F-4808-A06B-2352A84F6737}"/>
          </ac:grpSpMkLst>
        </pc:grpChg>
        <pc:grpChg chg="add mod">
          <ac:chgData name="酒井　良子" userId="90edd1d5-b2ba-4aa8-8eb1-5bb9703cb036" providerId="ADAL" clId="{EC37E4E5-5585-4FE7-9F9C-8CAA9990845B}" dt="2021-01-19T00:17:14.974" v="24" actId="1076"/>
          <ac:grpSpMkLst>
            <pc:docMk/>
            <pc:sldMk cId="3948386731" sldId="258"/>
            <ac:grpSpMk id="5" creationId="{A086CB04-2298-4FCD-92FB-22E107C6FD61}"/>
          </ac:grpSpMkLst>
        </pc:grpChg>
        <pc:grpChg chg="add mod">
          <ac:chgData name="酒井　良子" userId="90edd1d5-b2ba-4aa8-8eb1-5bb9703cb036" providerId="ADAL" clId="{EC37E4E5-5585-4FE7-9F9C-8CAA9990845B}" dt="2021-01-19T00:16:56.913" v="21" actId="1076"/>
          <ac:grpSpMkLst>
            <pc:docMk/>
            <pc:sldMk cId="3948386731" sldId="258"/>
            <ac:grpSpMk id="6" creationId="{964D5494-E8F9-4D16-8D45-EA9F76004FE9}"/>
          </ac:grpSpMkLst>
        </pc:grpChg>
        <pc:grpChg chg="add mod">
          <ac:chgData name="酒井　良子" userId="90edd1d5-b2ba-4aa8-8eb1-5bb9703cb036" providerId="ADAL" clId="{EC37E4E5-5585-4FE7-9F9C-8CAA9990845B}" dt="2021-01-19T00:17:43.648" v="27" actId="1076"/>
          <ac:grpSpMkLst>
            <pc:docMk/>
            <pc:sldMk cId="3948386731" sldId="258"/>
            <ac:grpSpMk id="21" creationId="{5F38A7FF-92B4-4821-82E6-DD9189EBA8B3}"/>
          </ac:grpSpMkLst>
        </pc:grpChg>
        <pc:grpChg chg="add mod">
          <ac:chgData name="酒井　良子" userId="90edd1d5-b2ba-4aa8-8eb1-5bb9703cb036" providerId="ADAL" clId="{EC37E4E5-5585-4FE7-9F9C-8CAA9990845B}" dt="2021-01-19T00:17:08.493" v="22" actId="1076"/>
          <ac:grpSpMkLst>
            <pc:docMk/>
            <pc:sldMk cId="3948386731" sldId="258"/>
            <ac:grpSpMk id="26" creationId="{368001F2-1C35-42E4-861C-C5FDA54371B1}"/>
          </ac:grpSpMkLst>
        </pc:grpChg>
        <pc:grpChg chg="mod">
          <ac:chgData name="酒井　良子" userId="90edd1d5-b2ba-4aa8-8eb1-5bb9703cb036" providerId="ADAL" clId="{EC37E4E5-5585-4FE7-9F9C-8CAA9990845B}" dt="2021-01-19T00:14:15.672" v="5" actId="164"/>
          <ac:grpSpMkLst>
            <pc:docMk/>
            <pc:sldMk cId="3948386731" sldId="258"/>
            <ac:grpSpMk id="41" creationId="{9CA58FD2-0792-42B9-A8FF-2D931705E1C1}"/>
          </ac:grpSpMkLst>
        </pc:grpChg>
        <pc:grpChg chg="mod">
          <ac:chgData name="酒井　良子" userId="90edd1d5-b2ba-4aa8-8eb1-5bb9703cb036" providerId="ADAL" clId="{EC37E4E5-5585-4FE7-9F9C-8CAA9990845B}" dt="2021-01-19T00:11:27.860" v="3" actId="207"/>
          <ac:grpSpMkLst>
            <pc:docMk/>
            <pc:sldMk cId="3948386731" sldId="258"/>
            <ac:grpSpMk id="43" creationId="{F0D9C5B2-19F0-4B97-BF6A-B167C208CB6D}"/>
          </ac:grpSpMkLst>
        </pc:grpChg>
        <pc:grpChg chg="mod">
          <ac:chgData name="酒井　良子" userId="90edd1d5-b2ba-4aa8-8eb1-5bb9703cb036" providerId="ADAL" clId="{EC37E4E5-5585-4FE7-9F9C-8CAA9990845B}" dt="2021-01-19T00:14:08.890" v="4" actId="164"/>
          <ac:grpSpMkLst>
            <pc:docMk/>
            <pc:sldMk cId="3948386731" sldId="258"/>
            <ac:grpSpMk id="92" creationId="{E4D663AB-960E-44C5-BA50-F8F74E1D1A3F}"/>
          </ac:grpSpMkLst>
        </pc:grpChg>
        <pc:grpChg chg="mod">
          <ac:chgData name="酒井　良子" userId="90edd1d5-b2ba-4aa8-8eb1-5bb9703cb036" providerId="ADAL" clId="{EC37E4E5-5585-4FE7-9F9C-8CAA9990845B}" dt="2021-01-19T00:14:22.705" v="6" actId="164"/>
          <ac:grpSpMkLst>
            <pc:docMk/>
            <pc:sldMk cId="3948386731" sldId="258"/>
            <ac:grpSpMk id="111" creationId="{EB040860-4D55-4715-8A87-34AA45D78077}"/>
          </ac:grpSpMkLst>
        </pc:grpChg>
        <pc:grpChg chg="mod">
          <ac:chgData name="酒井　良子" userId="90edd1d5-b2ba-4aa8-8eb1-5bb9703cb036" providerId="ADAL" clId="{EC37E4E5-5585-4FE7-9F9C-8CAA9990845B}" dt="2021-01-19T00:14:29.431" v="7" actId="164"/>
          <ac:grpSpMkLst>
            <pc:docMk/>
            <pc:sldMk cId="3948386731" sldId="258"/>
            <ac:grpSpMk id="131" creationId="{8269A634-C774-461E-90E8-00DD0042747F}"/>
          </ac:grpSpMkLst>
        </pc:grpChg>
        <pc:grpChg chg="mod">
          <ac:chgData name="酒井　良子" userId="90edd1d5-b2ba-4aa8-8eb1-5bb9703cb036" providerId="ADAL" clId="{EC37E4E5-5585-4FE7-9F9C-8CAA9990845B}" dt="2021-01-19T00:14:34.935" v="8" actId="164"/>
          <ac:grpSpMkLst>
            <pc:docMk/>
            <pc:sldMk cId="3948386731" sldId="258"/>
            <ac:grpSpMk id="152" creationId="{3B9B63F4-D8A7-4D23-8F9F-F19D396CC3A4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225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0866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9606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0415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7026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8598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1149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3776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403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15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760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9C2F64-E057-4AB0-9DB9-86FB736FCCA3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5A156-A19D-4425-9A54-C28EB6B41F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335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45436" y="8731546"/>
            <a:ext cx="1395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グループ化 23"/>
          <p:cNvGrpSpPr/>
          <p:nvPr/>
        </p:nvGrpSpPr>
        <p:grpSpPr>
          <a:xfrm>
            <a:off x="1603" y="401468"/>
            <a:ext cx="3123100" cy="1688243"/>
            <a:chOff x="10552" y="204849"/>
            <a:chExt cx="3123100" cy="1688243"/>
          </a:xfrm>
        </p:grpSpPr>
        <p:cxnSp>
          <p:nvCxnSpPr>
            <p:cNvPr id="7" name="直線矢印コネクタ 6"/>
            <p:cNvCxnSpPr/>
            <p:nvPr/>
          </p:nvCxnSpPr>
          <p:spPr>
            <a:xfrm>
              <a:off x="993053" y="1406769"/>
              <a:ext cx="180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1517575" y="1662260"/>
              <a:ext cx="10410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years)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正方形/長方形 8"/>
            <p:cNvSpPr/>
            <p:nvPr/>
          </p:nvSpPr>
          <p:spPr>
            <a:xfrm>
              <a:off x="993053" y="646714"/>
              <a:ext cx="1404000" cy="14679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896866" y="1488761"/>
              <a:ext cx="281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628918" y="1490050"/>
              <a:ext cx="281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440202" y="1476807"/>
              <a:ext cx="281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2038080" y="1488761"/>
              <a:ext cx="281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0552" y="604695"/>
              <a:ext cx="11043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DMARDs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JAKIs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801909" y="233789"/>
              <a:ext cx="4712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rt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直線矢印コネクタ 16"/>
            <p:cNvCxnSpPr/>
            <p:nvPr/>
          </p:nvCxnSpPr>
          <p:spPr>
            <a:xfrm>
              <a:off x="993053" y="424695"/>
              <a:ext cx="0" cy="18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矢印コネクタ 17"/>
            <p:cNvCxnSpPr/>
            <p:nvPr/>
          </p:nvCxnSpPr>
          <p:spPr>
            <a:xfrm>
              <a:off x="2395989" y="424695"/>
              <a:ext cx="0" cy="18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/>
            <p:cNvSpPr txBox="1"/>
            <p:nvPr/>
          </p:nvSpPr>
          <p:spPr>
            <a:xfrm>
              <a:off x="1658326" y="204849"/>
              <a:ext cx="14753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last day of the exposure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グループ化 24"/>
          <p:cNvGrpSpPr/>
          <p:nvPr/>
        </p:nvGrpSpPr>
        <p:grpSpPr>
          <a:xfrm>
            <a:off x="3502611" y="398640"/>
            <a:ext cx="3123100" cy="1688243"/>
            <a:chOff x="10552" y="204849"/>
            <a:chExt cx="3123100" cy="1688243"/>
          </a:xfrm>
        </p:grpSpPr>
        <p:cxnSp>
          <p:nvCxnSpPr>
            <p:cNvPr id="27" name="直線矢印コネクタ 26"/>
            <p:cNvCxnSpPr/>
            <p:nvPr/>
          </p:nvCxnSpPr>
          <p:spPr>
            <a:xfrm>
              <a:off x="993053" y="1406769"/>
              <a:ext cx="180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テキスト ボックス 27"/>
            <p:cNvSpPr txBox="1"/>
            <p:nvPr/>
          </p:nvSpPr>
          <p:spPr>
            <a:xfrm>
              <a:off x="1517575" y="1662260"/>
              <a:ext cx="10410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years)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正方形/長方形 28"/>
            <p:cNvSpPr/>
            <p:nvPr/>
          </p:nvSpPr>
          <p:spPr>
            <a:xfrm>
              <a:off x="993053" y="646714"/>
              <a:ext cx="1404000" cy="14679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896866" y="1488761"/>
              <a:ext cx="281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2628918" y="1490050"/>
              <a:ext cx="281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1440202" y="1476807"/>
              <a:ext cx="281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2038080" y="1488761"/>
              <a:ext cx="281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10552" y="604695"/>
              <a:ext cx="11043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TX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801909" y="233789"/>
              <a:ext cx="4712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rt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6" name="直線矢印コネクタ 35"/>
            <p:cNvCxnSpPr/>
            <p:nvPr/>
          </p:nvCxnSpPr>
          <p:spPr>
            <a:xfrm>
              <a:off x="993053" y="424695"/>
              <a:ext cx="0" cy="18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/>
            <p:cNvCxnSpPr/>
            <p:nvPr/>
          </p:nvCxnSpPr>
          <p:spPr>
            <a:xfrm>
              <a:off x="2395989" y="424695"/>
              <a:ext cx="0" cy="18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テキスト ボックス 37"/>
            <p:cNvSpPr txBox="1"/>
            <p:nvPr/>
          </p:nvSpPr>
          <p:spPr>
            <a:xfrm>
              <a:off x="1658326" y="204849"/>
              <a:ext cx="14753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last day of the exposure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" name="テキスト ボックス 38"/>
          <p:cNvSpPr txBox="1"/>
          <p:nvPr/>
        </p:nvSpPr>
        <p:spPr>
          <a:xfrm>
            <a:off x="210770" y="181622"/>
            <a:ext cx="32144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Received  bDMARDs/JAKIs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648391" y="199576"/>
            <a:ext cx="32144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Received  MTX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288143" y="2120327"/>
            <a:ext cx="3214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Received bDMARDs/JAKIs and MTX concomitantly, switched to bDMARDs/JAIKs only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F0D9C5B2-19F0-4B97-BF6A-B167C208CB6D}"/>
              </a:ext>
            </a:extLst>
          </p:cNvPr>
          <p:cNvGrpSpPr/>
          <p:nvPr/>
        </p:nvGrpSpPr>
        <p:grpSpPr>
          <a:xfrm>
            <a:off x="3945710" y="8488312"/>
            <a:ext cx="2863428" cy="627064"/>
            <a:chOff x="4024611" y="8279271"/>
            <a:chExt cx="2863428" cy="627064"/>
          </a:xfrm>
        </p:grpSpPr>
        <p:sp>
          <p:nvSpPr>
            <p:cNvPr id="20" name="正方形/長方形 19"/>
            <p:cNvSpPr/>
            <p:nvPr/>
          </p:nvSpPr>
          <p:spPr>
            <a:xfrm>
              <a:off x="4040873" y="8343070"/>
              <a:ext cx="444197" cy="13571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4509537" y="8279271"/>
              <a:ext cx="12027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n drug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4505616" y="8487649"/>
              <a:ext cx="1645104" cy="2308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servation period for MTX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矢印: 左右 3">
              <a:extLst>
                <a:ext uri="{FF2B5EF4-FFF2-40B4-BE49-F238E27FC236}">
                  <a16:creationId xmlns:a16="http://schemas.microsoft.com/office/drawing/2014/main" id="{36EA53C4-7950-4C13-9376-75F92B8C1FC3}"/>
                </a:ext>
              </a:extLst>
            </p:cNvPr>
            <p:cNvSpPr/>
            <p:nvPr/>
          </p:nvSpPr>
          <p:spPr>
            <a:xfrm>
              <a:off x="4024611" y="8541421"/>
              <a:ext cx="513718" cy="135678"/>
            </a:xfrm>
            <a:prstGeom prst="left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82" name="矢印: 左右 81">
              <a:extLst>
                <a:ext uri="{FF2B5EF4-FFF2-40B4-BE49-F238E27FC236}">
                  <a16:creationId xmlns:a16="http://schemas.microsoft.com/office/drawing/2014/main" id="{1A85AAE9-BE2D-43A1-B68D-DA828A4EF157}"/>
                </a:ext>
              </a:extLst>
            </p:cNvPr>
            <p:cNvSpPr/>
            <p:nvPr/>
          </p:nvSpPr>
          <p:spPr>
            <a:xfrm>
              <a:off x="4024611" y="8712725"/>
              <a:ext cx="513718" cy="135678"/>
            </a:xfrm>
            <a:prstGeom prst="leftRightArrow">
              <a:avLst/>
            </a:prstGeom>
            <a:pattFill prst="ltVert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D92A9C5A-D5BE-4BE8-85E3-56A1761D68AE}"/>
                </a:ext>
              </a:extLst>
            </p:cNvPr>
            <p:cNvSpPr txBox="1"/>
            <p:nvPr/>
          </p:nvSpPr>
          <p:spPr>
            <a:xfrm>
              <a:off x="4507105" y="8675503"/>
              <a:ext cx="23809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servation period for bDMARDs/JAKIs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6" name="矢印: 左右 85">
            <a:extLst>
              <a:ext uri="{FF2B5EF4-FFF2-40B4-BE49-F238E27FC236}">
                <a16:creationId xmlns:a16="http://schemas.microsoft.com/office/drawing/2014/main" id="{06B3BE39-4247-47D4-AB80-D889C7CCF7E9}"/>
              </a:ext>
            </a:extLst>
          </p:cNvPr>
          <p:cNvSpPr/>
          <p:nvPr/>
        </p:nvSpPr>
        <p:spPr>
          <a:xfrm>
            <a:off x="984104" y="1118797"/>
            <a:ext cx="1440000" cy="242287"/>
          </a:xfrm>
          <a:prstGeom prst="leftRightArrow">
            <a:avLst/>
          </a:prstGeom>
          <a:pattFill prst="ltVert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87" name="矢印: 左右 86">
            <a:extLst>
              <a:ext uri="{FF2B5EF4-FFF2-40B4-BE49-F238E27FC236}">
                <a16:creationId xmlns:a16="http://schemas.microsoft.com/office/drawing/2014/main" id="{C320228C-FFDA-4C4D-A65F-39E2C05346CE}"/>
              </a:ext>
            </a:extLst>
          </p:cNvPr>
          <p:cNvSpPr/>
          <p:nvPr/>
        </p:nvSpPr>
        <p:spPr>
          <a:xfrm>
            <a:off x="4495916" y="1173159"/>
            <a:ext cx="1368000" cy="191369"/>
          </a:xfrm>
          <a:prstGeom prst="left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CAED95B6-CFD6-4AA1-96FD-E73B50F1A943}"/>
              </a:ext>
            </a:extLst>
          </p:cNvPr>
          <p:cNvGrpSpPr/>
          <p:nvPr/>
        </p:nvGrpSpPr>
        <p:grpSpPr>
          <a:xfrm>
            <a:off x="147441" y="2316819"/>
            <a:ext cx="3123100" cy="1941282"/>
            <a:chOff x="148365" y="3065921"/>
            <a:chExt cx="3123100" cy="1941282"/>
          </a:xfrm>
        </p:grpSpPr>
        <p:grpSp>
          <p:nvGrpSpPr>
            <p:cNvPr id="62" name="グループ化 61"/>
            <p:cNvGrpSpPr/>
            <p:nvPr/>
          </p:nvGrpSpPr>
          <p:grpSpPr>
            <a:xfrm>
              <a:off x="148365" y="3065921"/>
              <a:ext cx="3123100" cy="1941282"/>
              <a:chOff x="208791" y="5189733"/>
              <a:chExt cx="3123100" cy="1941282"/>
            </a:xfrm>
          </p:grpSpPr>
          <p:sp>
            <p:nvSpPr>
              <p:cNvPr id="47" name="正方形/長方形 46"/>
              <p:cNvSpPr/>
              <p:nvPr/>
            </p:nvSpPr>
            <p:spPr>
              <a:xfrm>
                <a:off x="1191292" y="5666768"/>
                <a:ext cx="1404000" cy="14679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59" name="グループ化 58"/>
              <p:cNvGrpSpPr/>
              <p:nvPr/>
            </p:nvGrpSpPr>
            <p:grpSpPr>
              <a:xfrm>
                <a:off x="1105917" y="6644692"/>
                <a:ext cx="2013406" cy="486323"/>
                <a:chOff x="1095105" y="6426823"/>
                <a:chExt cx="2013406" cy="486323"/>
              </a:xfrm>
            </p:grpSpPr>
            <p:cxnSp>
              <p:nvCxnSpPr>
                <p:cNvPr id="45" name="直線矢印コネクタ 44"/>
                <p:cNvCxnSpPr/>
                <p:nvPr/>
              </p:nvCxnSpPr>
              <p:spPr>
                <a:xfrm>
                  <a:off x="1191292" y="6426823"/>
                  <a:ext cx="1800000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テキスト ボックス 45"/>
                <p:cNvSpPr txBox="1"/>
                <p:nvPr/>
              </p:nvSpPr>
              <p:spPr>
                <a:xfrm>
                  <a:off x="1715814" y="6682314"/>
                  <a:ext cx="104100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ime (years)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テキスト ボックス 47"/>
                <p:cNvSpPr txBox="1"/>
                <p:nvPr/>
              </p:nvSpPr>
              <p:spPr>
                <a:xfrm>
                  <a:off x="1095105" y="6508815"/>
                  <a:ext cx="2813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テキスト ボックス 48"/>
                <p:cNvSpPr txBox="1"/>
                <p:nvPr/>
              </p:nvSpPr>
              <p:spPr>
                <a:xfrm>
                  <a:off x="2827157" y="6510104"/>
                  <a:ext cx="2813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テキスト ボックス 49"/>
                <p:cNvSpPr txBox="1"/>
                <p:nvPr/>
              </p:nvSpPr>
              <p:spPr>
                <a:xfrm>
                  <a:off x="1638441" y="6496861"/>
                  <a:ext cx="2813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テキスト ボックス 50"/>
                <p:cNvSpPr txBox="1"/>
                <p:nvPr/>
              </p:nvSpPr>
              <p:spPr>
                <a:xfrm>
                  <a:off x="2236319" y="6508815"/>
                  <a:ext cx="28135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2" name="テキスト ボックス 51"/>
              <p:cNvSpPr txBox="1"/>
              <p:nvPr/>
            </p:nvSpPr>
            <p:spPr>
              <a:xfrm>
                <a:off x="208791" y="5589579"/>
                <a:ext cx="11043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MARDs</a:t>
                </a:r>
                <a:r>
                  <a:rPr kumimoji="1"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JAKIs</a:t>
                </a:r>
                <a:endParaRPr kumimoji="1" lang="ja-JP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テキスト ボックス 52"/>
              <p:cNvSpPr txBox="1"/>
              <p:nvPr/>
            </p:nvSpPr>
            <p:spPr>
              <a:xfrm>
                <a:off x="1000148" y="5218673"/>
                <a:ext cx="4712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art</a:t>
                </a:r>
                <a:endParaRPr kumimoji="1" lang="ja-JP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4" name="直線矢印コネクタ 53"/>
              <p:cNvCxnSpPr/>
              <p:nvPr/>
            </p:nvCxnSpPr>
            <p:spPr>
              <a:xfrm>
                <a:off x="1191292" y="5409579"/>
                <a:ext cx="0" cy="180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線矢印コネクタ 54"/>
              <p:cNvCxnSpPr/>
              <p:nvPr/>
            </p:nvCxnSpPr>
            <p:spPr>
              <a:xfrm>
                <a:off x="2594228" y="5409579"/>
                <a:ext cx="0" cy="180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テキスト ボックス 55"/>
              <p:cNvSpPr txBox="1"/>
              <p:nvPr/>
            </p:nvSpPr>
            <p:spPr>
              <a:xfrm>
                <a:off x="1856565" y="5189733"/>
                <a:ext cx="147532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e last day of the exposure</a:t>
                </a:r>
                <a:endParaRPr kumimoji="1" lang="ja-JP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正方形/長方形 59"/>
              <p:cNvSpPr/>
              <p:nvPr/>
            </p:nvSpPr>
            <p:spPr>
              <a:xfrm>
                <a:off x="1198250" y="5901494"/>
                <a:ext cx="540000" cy="14679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208791" y="5880601"/>
                <a:ext cx="11043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X</a:t>
                </a:r>
                <a:endParaRPr kumimoji="1" lang="ja-JP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8" name="矢印: 左右 87">
              <a:extLst>
                <a:ext uri="{FF2B5EF4-FFF2-40B4-BE49-F238E27FC236}">
                  <a16:creationId xmlns:a16="http://schemas.microsoft.com/office/drawing/2014/main" id="{8E80BC36-DBF7-49E2-AB31-3C1BA157944C}"/>
                </a:ext>
              </a:extLst>
            </p:cNvPr>
            <p:cNvSpPr/>
            <p:nvPr/>
          </p:nvSpPr>
          <p:spPr>
            <a:xfrm>
              <a:off x="1101155" y="4041385"/>
              <a:ext cx="1440000" cy="206870"/>
            </a:xfrm>
            <a:prstGeom prst="leftRightArrow">
              <a:avLst/>
            </a:prstGeom>
            <a:pattFill prst="ltVert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A086CB04-2298-4FCD-92FB-22E107C6FD61}"/>
              </a:ext>
            </a:extLst>
          </p:cNvPr>
          <p:cNvGrpSpPr/>
          <p:nvPr/>
        </p:nvGrpSpPr>
        <p:grpSpPr>
          <a:xfrm>
            <a:off x="140107" y="6525173"/>
            <a:ext cx="3360248" cy="2160587"/>
            <a:chOff x="3502611" y="2119882"/>
            <a:chExt cx="3360248" cy="2160587"/>
          </a:xfrm>
        </p:grpSpPr>
        <p:sp>
          <p:nvSpPr>
            <p:cNvPr id="42" name="テキスト ボックス 41"/>
            <p:cNvSpPr txBox="1"/>
            <p:nvPr/>
          </p:nvSpPr>
          <p:spPr>
            <a:xfrm>
              <a:off x="3648391" y="2119882"/>
              <a:ext cx="32144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) Received MTX, switched to bDMARDs/JAKIs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1" name="グループ化 40">
              <a:extLst>
                <a:ext uri="{FF2B5EF4-FFF2-40B4-BE49-F238E27FC236}">
                  <a16:creationId xmlns:a16="http://schemas.microsoft.com/office/drawing/2014/main" id="{9CA58FD2-0792-42B9-A8FF-2D931705E1C1}"/>
                </a:ext>
              </a:extLst>
            </p:cNvPr>
            <p:cNvGrpSpPr/>
            <p:nvPr/>
          </p:nvGrpSpPr>
          <p:grpSpPr>
            <a:xfrm>
              <a:off x="3502611" y="2339187"/>
              <a:ext cx="3123100" cy="1941282"/>
              <a:chOff x="3557138" y="3119685"/>
              <a:chExt cx="3123100" cy="1941282"/>
            </a:xfrm>
          </p:grpSpPr>
          <p:grpSp>
            <p:nvGrpSpPr>
              <p:cNvPr id="64" name="グループ化 63"/>
              <p:cNvGrpSpPr/>
              <p:nvPr/>
            </p:nvGrpSpPr>
            <p:grpSpPr>
              <a:xfrm>
                <a:off x="3557138" y="3119685"/>
                <a:ext cx="3123100" cy="1941282"/>
                <a:chOff x="208791" y="5189733"/>
                <a:chExt cx="3123100" cy="1941282"/>
              </a:xfrm>
            </p:grpSpPr>
            <p:sp>
              <p:nvSpPr>
                <p:cNvPr id="66" name="正方形/長方形 65"/>
                <p:cNvSpPr/>
                <p:nvPr/>
              </p:nvSpPr>
              <p:spPr>
                <a:xfrm>
                  <a:off x="1739938" y="5666768"/>
                  <a:ext cx="864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67" name="グループ化 66"/>
                <p:cNvGrpSpPr/>
                <p:nvPr/>
              </p:nvGrpSpPr>
              <p:grpSpPr>
                <a:xfrm>
                  <a:off x="1105917" y="6644692"/>
                  <a:ext cx="2013406" cy="486323"/>
                  <a:chOff x="1095105" y="6426823"/>
                  <a:chExt cx="2013406" cy="486323"/>
                </a:xfrm>
              </p:grpSpPr>
              <p:cxnSp>
                <p:nvCxnSpPr>
                  <p:cNvPr id="75" name="直線矢印コネクタ 74"/>
                  <p:cNvCxnSpPr/>
                  <p:nvPr/>
                </p:nvCxnSpPr>
                <p:spPr>
                  <a:xfrm>
                    <a:off x="1191292" y="6426823"/>
                    <a:ext cx="1800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6" name="テキスト ボックス 75"/>
                  <p:cNvSpPr txBox="1"/>
                  <p:nvPr/>
                </p:nvSpPr>
                <p:spPr>
                  <a:xfrm>
                    <a:off x="1715814" y="6682314"/>
                    <a:ext cx="104100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ime (years)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7" name="テキスト ボックス 76"/>
                  <p:cNvSpPr txBox="1"/>
                  <p:nvPr/>
                </p:nvSpPr>
                <p:spPr>
                  <a:xfrm>
                    <a:off x="1095105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8" name="テキスト ボックス 77"/>
                  <p:cNvSpPr txBox="1"/>
                  <p:nvPr/>
                </p:nvSpPr>
                <p:spPr>
                  <a:xfrm>
                    <a:off x="2827157" y="6510104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9" name="テキスト ボックス 78"/>
                  <p:cNvSpPr txBox="1"/>
                  <p:nvPr/>
                </p:nvSpPr>
                <p:spPr>
                  <a:xfrm>
                    <a:off x="1638441" y="6496861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0" name="テキスト ボックス 79"/>
                  <p:cNvSpPr txBox="1"/>
                  <p:nvPr/>
                </p:nvSpPr>
                <p:spPr>
                  <a:xfrm>
                    <a:off x="2236319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68" name="テキスト ボックス 67"/>
                <p:cNvSpPr txBox="1"/>
                <p:nvPr/>
              </p:nvSpPr>
              <p:spPr>
                <a:xfrm>
                  <a:off x="208791" y="5589579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DMARDs</a:t>
                  </a:r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JAKIs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テキスト ボックス 68"/>
                <p:cNvSpPr txBox="1"/>
                <p:nvPr/>
              </p:nvSpPr>
              <p:spPr>
                <a:xfrm>
                  <a:off x="1000148" y="5218673"/>
                  <a:ext cx="4712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art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0" name="直線矢印コネクタ 69"/>
                <p:cNvCxnSpPr/>
                <p:nvPr/>
              </p:nvCxnSpPr>
              <p:spPr>
                <a:xfrm>
                  <a:off x="1191292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直線矢印コネクタ 70"/>
                <p:cNvCxnSpPr/>
                <p:nvPr/>
              </p:nvCxnSpPr>
              <p:spPr>
                <a:xfrm>
                  <a:off x="2594228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" name="テキスト ボックス 71"/>
                <p:cNvSpPr txBox="1"/>
                <p:nvPr/>
              </p:nvSpPr>
              <p:spPr>
                <a:xfrm>
                  <a:off x="1856565" y="5189733"/>
                  <a:ext cx="147532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he last day of the exposure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正方形/長方形 72"/>
                <p:cNvSpPr/>
                <p:nvPr/>
              </p:nvSpPr>
              <p:spPr>
                <a:xfrm>
                  <a:off x="1198250" y="5901494"/>
                  <a:ext cx="540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74" name="テキスト ボックス 73"/>
                <p:cNvSpPr txBox="1"/>
                <p:nvPr/>
              </p:nvSpPr>
              <p:spPr>
                <a:xfrm>
                  <a:off x="208791" y="5880601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TX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9" name="矢印: 左右 88">
                <a:extLst>
                  <a:ext uri="{FF2B5EF4-FFF2-40B4-BE49-F238E27FC236}">
                    <a16:creationId xmlns:a16="http://schemas.microsoft.com/office/drawing/2014/main" id="{CAA546F5-2775-462A-A8FA-47A14D7EC469}"/>
                  </a:ext>
                </a:extLst>
              </p:cNvPr>
              <p:cNvSpPr/>
              <p:nvPr/>
            </p:nvSpPr>
            <p:spPr>
              <a:xfrm>
                <a:off x="4546376" y="4072598"/>
                <a:ext cx="513718" cy="230832"/>
              </a:xfrm>
              <a:prstGeom prst="left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90" name="矢印: 左右 89">
                <a:extLst>
                  <a:ext uri="{FF2B5EF4-FFF2-40B4-BE49-F238E27FC236}">
                    <a16:creationId xmlns:a16="http://schemas.microsoft.com/office/drawing/2014/main" id="{0E7C49BB-5C97-40BB-B40F-5F0DCDE7E44E}"/>
                  </a:ext>
                </a:extLst>
              </p:cNvPr>
              <p:cNvSpPr/>
              <p:nvPr/>
            </p:nvSpPr>
            <p:spPr>
              <a:xfrm>
                <a:off x="5086597" y="4068959"/>
                <a:ext cx="900000" cy="230832"/>
              </a:xfrm>
              <a:prstGeom prst="leftRightArrow">
                <a:avLst/>
              </a:prstGeom>
              <a:pattFill prst="lt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EA2F120-9A0F-4808-A06B-2352A84F6737}"/>
              </a:ext>
            </a:extLst>
          </p:cNvPr>
          <p:cNvGrpSpPr/>
          <p:nvPr/>
        </p:nvGrpSpPr>
        <p:grpSpPr>
          <a:xfrm>
            <a:off x="3572945" y="2095358"/>
            <a:ext cx="3765543" cy="2104890"/>
            <a:chOff x="109814" y="4244068"/>
            <a:chExt cx="3765543" cy="2104890"/>
          </a:xfrm>
        </p:grpSpPr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C8B4FDA8-6844-4CCD-B089-337269D08768}"/>
                </a:ext>
              </a:extLst>
            </p:cNvPr>
            <p:cNvSpPr txBox="1"/>
            <p:nvPr/>
          </p:nvSpPr>
          <p:spPr>
            <a:xfrm>
              <a:off x="109814" y="4244068"/>
              <a:ext cx="35070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 Received </a:t>
              </a:r>
              <a:r>
                <a:rPr kumimoji="1" lang="en-US" altLang="ja-JP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DMARDs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JAKIs and MTX concomitantly, switched to MTX only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2" name="グループ化 91">
              <a:extLst>
                <a:ext uri="{FF2B5EF4-FFF2-40B4-BE49-F238E27FC236}">
                  <a16:creationId xmlns:a16="http://schemas.microsoft.com/office/drawing/2014/main" id="{E4D663AB-960E-44C5-BA50-F8F74E1D1A3F}"/>
                </a:ext>
              </a:extLst>
            </p:cNvPr>
            <p:cNvGrpSpPr/>
            <p:nvPr/>
          </p:nvGrpSpPr>
          <p:grpSpPr>
            <a:xfrm>
              <a:off x="126556" y="4436616"/>
              <a:ext cx="3748801" cy="1912342"/>
              <a:chOff x="148365" y="3094861"/>
              <a:chExt cx="3529634" cy="1912342"/>
            </a:xfrm>
          </p:grpSpPr>
          <p:grpSp>
            <p:nvGrpSpPr>
              <p:cNvPr id="93" name="グループ化 92">
                <a:extLst>
                  <a:ext uri="{FF2B5EF4-FFF2-40B4-BE49-F238E27FC236}">
                    <a16:creationId xmlns:a16="http://schemas.microsoft.com/office/drawing/2014/main" id="{D475B59F-375F-4E8E-A71E-3773482DC87C}"/>
                  </a:ext>
                </a:extLst>
              </p:cNvPr>
              <p:cNvGrpSpPr/>
              <p:nvPr/>
            </p:nvGrpSpPr>
            <p:grpSpPr>
              <a:xfrm>
                <a:off x="148365" y="3094861"/>
                <a:ext cx="3529634" cy="1912342"/>
                <a:chOff x="208791" y="5218673"/>
                <a:chExt cx="3529634" cy="1912342"/>
              </a:xfrm>
            </p:grpSpPr>
            <p:sp>
              <p:nvSpPr>
                <p:cNvPr id="95" name="正方形/長方形 94">
                  <a:extLst>
                    <a:ext uri="{FF2B5EF4-FFF2-40B4-BE49-F238E27FC236}">
                      <a16:creationId xmlns:a16="http://schemas.microsoft.com/office/drawing/2014/main" id="{B16BB8EF-3BD7-4451-A929-530FCDE0228F}"/>
                    </a:ext>
                  </a:extLst>
                </p:cNvPr>
                <p:cNvSpPr/>
                <p:nvPr/>
              </p:nvSpPr>
              <p:spPr>
                <a:xfrm>
                  <a:off x="1191292" y="5666768"/>
                  <a:ext cx="576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96" name="グループ化 95">
                  <a:extLst>
                    <a:ext uri="{FF2B5EF4-FFF2-40B4-BE49-F238E27FC236}">
                      <a16:creationId xmlns:a16="http://schemas.microsoft.com/office/drawing/2014/main" id="{FE98C4A0-4BF0-42FA-9EB4-D050C1944528}"/>
                    </a:ext>
                  </a:extLst>
                </p:cNvPr>
                <p:cNvGrpSpPr/>
                <p:nvPr/>
              </p:nvGrpSpPr>
              <p:grpSpPr>
                <a:xfrm>
                  <a:off x="1105917" y="6644692"/>
                  <a:ext cx="2013406" cy="486323"/>
                  <a:chOff x="1095105" y="6426823"/>
                  <a:chExt cx="2013406" cy="486323"/>
                </a:xfrm>
              </p:grpSpPr>
              <p:cxnSp>
                <p:nvCxnSpPr>
                  <p:cNvPr id="104" name="直線矢印コネクタ 103">
                    <a:extLst>
                      <a:ext uri="{FF2B5EF4-FFF2-40B4-BE49-F238E27FC236}">
                        <a16:creationId xmlns:a16="http://schemas.microsoft.com/office/drawing/2014/main" id="{A18260AB-98B3-427B-9D10-CB9F7601A2EB}"/>
                      </a:ext>
                    </a:extLst>
                  </p:cNvPr>
                  <p:cNvCxnSpPr/>
                  <p:nvPr/>
                </p:nvCxnSpPr>
                <p:spPr>
                  <a:xfrm>
                    <a:off x="1191292" y="6426823"/>
                    <a:ext cx="1800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5" name="テキスト ボックス 104">
                    <a:extLst>
                      <a:ext uri="{FF2B5EF4-FFF2-40B4-BE49-F238E27FC236}">
                        <a16:creationId xmlns:a16="http://schemas.microsoft.com/office/drawing/2014/main" id="{DB9E81C3-7AE2-42FC-9DA5-6F19E5422EA2}"/>
                      </a:ext>
                    </a:extLst>
                  </p:cNvPr>
                  <p:cNvSpPr txBox="1"/>
                  <p:nvPr/>
                </p:nvSpPr>
                <p:spPr>
                  <a:xfrm>
                    <a:off x="1715814" y="6682314"/>
                    <a:ext cx="104100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ime (years)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6" name="テキスト ボックス 105">
                    <a:extLst>
                      <a:ext uri="{FF2B5EF4-FFF2-40B4-BE49-F238E27FC236}">
                        <a16:creationId xmlns:a16="http://schemas.microsoft.com/office/drawing/2014/main" id="{6746FA25-FAAD-4D98-8F95-CED2CA692AEE}"/>
                      </a:ext>
                    </a:extLst>
                  </p:cNvPr>
                  <p:cNvSpPr txBox="1"/>
                  <p:nvPr/>
                </p:nvSpPr>
                <p:spPr>
                  <a:xfrm>
                    <a:off x="1095105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7" name="テキスト ボックス 106">
                    <a:extLst>
                      <a:ext uri="{FF2B5EF4-FFF2-40B4-BE49-F238E27FC236}">
                        <a16:creationId xmlns:a16="http://schemas.microsoft.com/office/drawing/2014/main" id="{D770092E-7943-485E-BEB4-549C94EA4432}"/>
                      </a:ext>
                    </a:extLst>
                  </p:cNvPr>
                  <p:cNvSpPr txBox="1"/>
                  <p:nvPr/>
                </p:nvSpPr>
                <p:spPr>
                  <a:xfrm>
                    <a:off x="2827157" y="6510104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8" name="テキスト ボックス 107">
                    <a:extLst>
                      <a:ext uri="{FF2B5EF4-FFF2-40B4-BE49-F238E27FC236}">
                        <a16:creationId xmlns:a16="http://schemas.microsoft.com/office/drawing/2014/main" id="{42A1CB9D-3341-457D-9C79-F615CB228487}"/>
                      </a:ext>
                    </a:extLst>
                  </p:cNvPr>
                  <p:cNvSpPr txBox="1"/>
                  <p:nvPr/>
                </p:nvSpPr>
                <p:spPr>
                  <a:xfrm>
                    <a:off x="1638441" y="6496861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9" name="テキスト ボックス 108">
                    <a:extLst>
                      <a:ext uri="{FF2B5EF4-FFF2-40B4-BE49-F238E27FC236}">
                        <a16:creationId xmlns:a16="http://schemas.microsoft.com/office/drawing/2014/main" id="{0EBEAFBC-9AAA-4E0F-A3D1-9E5254A46BB8}"/>
                      </a:ext>
                    </a:extLst>
                  </p:cNvPr>
                  <p:cNvSpPr txBox="1"/>
                  <p:nvPr/>
                </p:nvSpPr>
                <p:spPr>
                  <a:xfrm>
                    <a:off x="2236319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97" name="テキスト ボックス 96">
                  <a:extLst>
                    <a:ext uri="{FF2B5EF4-FFF2-40B4-BE49-F238E27FC236}">
                      <a16:creationId xmlns:a16="http://schemas.microsoft.com/office/drawing/2014/main" id="{4ADB6A47-7AA9-4E8D-BD37-4F8704A0FAFD}"/>
                    </a:ext>
                  </a:extLst>
                </p:cNvPr>
                <p:cNvSpPr txBox="1"/>
                <p:nvPr/>
              </p:nvSpPr>
              <p:spPr>
                <a:xfrm>
                  <a:off x="208791" y="5589579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DMARDs</a:t>
                  </a:r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JAKIs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8" name="テキスト ボックス 97">
                  <a:extLst>
                    <a:ext uri="{FF2B5EF4-FFF2-40B4-BE49-F238E27FC236}">
                      <a16:creationId xmlns:a16="http://schemas.microsoft.com/office/drawing/2014/main" id="{D82DAB6C-88D4-4FCC-9490-7CBB22F6EBA2}"/>
                    </a:ext>
                  </a:extLst>
                </p:cNvPr>
                <p:cNvSpPr txBox="1"/>
                <p:nvPr/>
              </p:nvSpPr>
              <p:spPr>
                <a:xfrm>
                  <a:off x="1000148" y="5218673"/>
                  <a:ext cx="4712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art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99" name="直線矢印コネクタ 98">
                  <a:extLst>
                    <a:ext uri="{FF2B5EF4-FFF2-40B4-BE49-F238E27FC236}">
                      <a16:creationId xmlns:a16="http://schemas.microsoft.com/office/drawing/2014/main" id="{22CD8BB8-5D6D-4C1A-A9D2-33A67C14F472}"/>
                    </a:ext>
                  </a:extLst>
                </p:cNvPr>
                <p:cNvCxnSpPr/>
                <p:nvPr/>
              </p:nvCxnSpPr>
              <p:spPr>
                <a:xfrm>
                  <a:off x="1191292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直線矢印コネクタ 99">
                  <a:extLst>
                    <a:ext uri="{FF2B5EF4-FFF2-40B4-BE49-F238E27FC236}">
                      <a16:creationId xmlns:a16="http://schemas.microsoft.com/office/drawing/2014/main" id="{2F273FF4-90D4-4B1F-A5F1-466CA981085D}"/>
                    </a:ext>
                  </a:extLst>
                </p:cNvPr>
                <p:cNvCxnSpPr/>
                <p:nvPr/>
              </p:nvCxnSpPr>
              <p:spPr>
                <a:xfrm>
                  <a:off x="1762018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1" name="テキスト ボックス 100">
                  <a:extLst>
                    <a:ext uri="{FF2B5EF4-FFF2-40B4-BE49-F238E27FC236}">
                      <a16:creationId xmlns:a16="http://schemas.microsoft.com/office/drawing/2014/main" id="{7FD78192-5C00-4801-955B-2C759360D807}"/>
                    </a:ext>
                  </a:extLst>
                </p:cNvPr>
                <p:cNvSpPr txBox="1"/>
                <p:nvPr/>
              </p:nvSpPr>
              <p:spPr>
                <a:xfrm>
                  <a:off x="1310570" y="5230857"/>
                  <a:ext cx="242785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he last day of the exposure 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" name="正方形/長方形 101">
                  <a:extLst>
                    <a:ext uri="{FF2B5EF4-FFF2-40B4-BE49-F238E27FC236}">
                      <a16:creationId xmlns:a16="http://schemas.microsoft.com/office/drawing/2014/main" id="{6E5DB0D8-FABF-486F-B635-C7F3BDDBAD7E}"/>
                    </a:ext>
                  </a:extLst>
                </p:cNvPr>
                <p:cNvSpPr/>
                <p:nvPr/>
              </p:nvSpPr>
              <p:spPr>
                <a:xfrm>
                  <a:off x="1198250" y="5901494"/>
                  <a:ext cx="1404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3" name="テキスト ボックス 102">
                  <a:extLst>
                    <a:ext uri="{FF2B5EF4-FFF2-40B4-BE49-F238E27FC236}">
                      <a16:creationId xmlns:a16="http://schemas.microsoft.com/office/drawing/2014/main" id="{8FCC30AF-835D-4DF9-A3F2-170BAD1D07BA}"/>
                    </a:ext>
                  </a:extLst>
                </p:cNvPr>
                <p:cNvSpPr txBox="1"/>
                <p:nvPr/>
              </p:nvSpPr>
              <p:spPr>
                <a:xfrm>
                  <a:off x="208791" y="5880601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TX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4" name="矢印: 左右 93">
                <a:extLst>
                  <a:ext uri="{FF2B5EF4-FFF2-40B4-BE49-F238E27FC236}">
                    <a16:creationId xmlns:a16="http://schemas.microsoft.com/office/drawing/2014/main" id="{9901060F-5518-4A32-9DD2-F1279A8C5B59}"/>
                  </a:ext>
                </a:extLst>
              </p:cNvPr>
              <p:cNvSpPr/>
              <p:nvPr/>
            </p:nvSpPr>
            <p:spPr>
              <a:xfrm>
                <a:off x="1101155" y="4041385"/>
                <a:ext cx="648000" cy="206870"/>
              </a:xfrm>
              <a:prstGeom prst="leftRightArrow">
                <a:avLst/>
              </a:prstGeom>
              <a:pattFill prst="lt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964D5494-E8F9-4D16-8D45-EA9F76004FE9}"/>
              </a:ext>
            </a:extLst>
          </p:cNvPr>
          <p:cNvGrpSpPr/>
          <p:nvPr/>
        </p:nvGrpSpPr>
        <p:grpSpPr>
          <a:xfrm>
            <a:off x="155097" y="4293632"/>
            <a:ext cx="3123100" cy="2071166"/>
            <a:chOff x="3687921" y="4294183"/>
            <a:chExt cx="3123100" cy="2071166"/>
          </a:xfrm>
        </p:grpSpPr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8B02FEC0-03FC-48A3-BAE7-D5052FFF9E44}"/>
                </a:ext>
              </a:extLst>
            </p:cNvPr>
            <p:cNvSpPr txBox="1"/>
            <p:nvPr/>
          </p:nvSpPr>
          <p:spPr>
            <a:xfrm>
              <a:off x="3734178" y="4294183"/>
              <a:ext cx="30321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) Received MTX, added </a:t>
              </a:r>
              <a:r>
                <a:rPr kumimoji="1" lang="en-US" altLang="ja-JP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DMARDs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JAKIs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1" name="グループ化 110">
              <a:extLst>
                <a:ext uri="{FF2B5EF4-FFF2-40B4-BE49-F238E27FC236}">
                  <a16:creationId xmlns:a16="http://schemas.microsoft.com/office/drawing/2014/main" id="{EB040860-4D55-4715-8A87-34AA45D78077}"/>
                </a:ext>
              </a:extLst>
            </p:cNvPr>
            <p:cNvGrpSpPr/>
            <p:nvPr/>
          </p:nvGrpSpPr>
          <p:grpSpPr>
            <a:xfrm>
              <a:off x="3687921" y="4424067"/>
              <a:ext cx="3123100" cy="1941282"/>
              <a:chOff x="3557138" y="3119685"/>
              <a:chExt cx="3123100" cy="1941282"/>
            </a:xfrm>
          </p:grpSpPr>
          <p:grpSp>
            <p:nvGrpSpPr>
              <p:cNvPr id="112" name="グループ化 111">
                <a:extLst>
                  <a:ext uri="{FF2B5EF4-FFF2-40B4-BE49-F238E27FC236}">
                    <a16:creationId xmlns:a16="http://schemas.microsoft.com/office/drawing/2014/main" id="{84460CF0-42F2-4D8F-A390-973B43798608}"/>
                  </a:ext>
                </a:extLst>
              </p:cNvPr>
              <p:cNvGrpSpPr/>
              <p:nvPr/>
            </p:nvGrpSpPr>
            <p:grpSpPr>
              <a:xfrm>
                <a:off x="3557138" y="3119685"/>
                <a:ext cx="3123100" cy="1941282"/>
                <a:chOff x="208791" y="5189733"/>
                <a:chExt cx="3123100" cy="1941282"/>
              </a:xfrm>
            </p:grpSpPr>
            <p:sp>
              <p:nvSpPr>
                <p:cNvPr id="115" name="正方形/長方形 114">
                  <a:extLst>
                    <a:ext uri="{FF2B5EF4-FFF2-40B4-BE49-F238E27FC236}">
                      <a16:creationId xmlns:a16="http://schemas.microsoft.com/office/drawing/2014/main" id="{83776087-D1B2-4346-973A-33F26862E0FD}"/>
                    </a:ext>
                  </a:extLst>
                </p:cNvPr>
                <p:cNvSpPr/>
                <p:nvPr/>
              </p:nvSpPr>
              <p:spPr>
                <a:xfrm>
                  <a:off x="1739938" y="5666768"/>
                  <a:ext cx="864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116" name="グループ化 115">
                  <a:extLst>
                    <a:ext uri="{FF2B5EF4-FFF2-40B4-BE49-F238E27FC236}">
                      <a16:creationId xmlns:a16="http://schemas.microsoft.com/office/drawing/2014/main" id="{AC6F63FE-52AC-4B5B-935E-A2B18DE636B5}"/>
                    </a:ext>
                  </a:extLst>
                </p:cNvPr>
                <p:cNvGrpSpPr/>
                <p:nvPr/>
              </p:nvGrpSpPr>
              <p:grpSpPr>
                <a:xfrm>
                  <a:off x="1105917" y="6644692"/>
                  <a:ext cx="2013406" cy="486323"/>
                  <a:chOff x="1095105" y="6426823"/>
                  <a:chExt cx="2013406" cy="486323"/>
                </a:xfrm>
              </p:grpSpPr>
              <p:cxnSp>
                <p:nvCxnSpPr>
                  <p:cNvPr id="124" name="直線矢印コネクタ 123">
                    <a:extLst>
                      <a:ext uri="{FF2B5EF4-FFF2-40B4-BE49-F238E27FC236}">
                        <a16:creationId xmlns:a16="http://schemas.microsoft.com/office/drawing/2014/main" id="{28DA3EB8-9C61-4713-87F2-A1D2D227CB8B}"/>
                      </a:ext>
                    </a:extLst>
                  </p:cNvPr>
                  <p:cNvCxnSpPr/>
                  <p:nvPr/>
                </p:nvCxnSpPr>
                <p:spPr>
                  <a:xfrm>
                    <a:off x="1191292" y="6426823"/>
                    <a:ext cx="1800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5" name="テキスト ボックス 124">
                    <a:extLst>
                      <a:ext uri="{FF2B5EF4-FFF2-40B4-BE49-F238E27FC236}">
                        <a16:creationId xmlns:a16="http://schemas.microsoft.com/office/drawing/2014/main" id="{B07A589D-D809-449E-BCD8-E4E1FBDE9102}"/>
                      </a:ext>
                    </a:extLst>
                  </p:cNvPr>
                  <p:cNvSpPr txBox="1"/>
                  <p:nvPr/>
                </p:nvSpPr>
                <p:spPr>
                  <a:xfrm>
                    <a:off x="1715814" y="6682314"/>
                    <a:ext cx="104100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ime (years)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6" name="テキスト ボックス 125">
                    <a:extLst>
                      <a:ext uri="{FF2B5EF4-FFF2-40B4-BE49-F238E27FC236}">
                        <a16:creationId xmlns:a16="http://schemas.microsoft.com/office/drawing/2014/main" id="{09BE890B-B6AD-42C5-8D91-F7D0D9A0CE46}"/>
                      </a:ext>
                    </a:extLst>
                  </p:cNvPr>
                  <p:cNvSpPr txBox="1"/>
                  <p:nvPr/>
                </p:nvSpPr>
                <p:spPr>
                  <a:xfrm>
                    <a:off x="1095105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7" name="テキスト ボックス 126">
                    <a:extLst>
                      <a:ext uri="{FF2B5EF4-FFF2-40B4-BE49-F238E27FC236}">
                        <a16:creationId xmlns:a16="http://schemas.microsoft.com/office/drawing/2014/main" id="{68AD63CE-493C-49CD-819D-14BCC7A75350}"/>
                      </a:ext>
                    </a:extLst>
                  </p:cNvPr>
                  <p:cNvSpPr txBox="1"/>
                  <p:nvPr/>
                </p:nvSpPr>
                <p:spPr>
                  <a:xfrm>
                    <a:off x="2827157" y="6510104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8" name="テキスト ボックス 127">
                    <a:extLst>
                      <a:ext uri="{FF2B5EF4-FFF2-40B4-BE49-F238E27FC236}">
                        <a16:creationId xmlns:a16="http://schemas.microsoft.com/office/drawing/2014/main" id="{1C7D3644-C67A-46BE-A6C3-B71D3ED5EC91}"/>
                      </a:ext>
                    </a:extLst>
                  </p:cNvPr>
                  <p:cNvSpPr txBox="1"/>
                  <p:nvPr/>
                </p:nvSpPr>
                <p:spPr>
                  <a:xfrm>
                    <a:off x="1638441" y="6496861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9" name="テキスト ボックス 128">
                    <a:extLst>
                      <a:ext uri="{FF2B5EF4-FFF2-40B4-BE49-F238E27FC236}">
                        <a16:creationId xmlns:a16="http://schemas.microsoft.com/office/drawing/2014/main" id="{6608AF83-087D-433A-B0AB-FEF547098BE7}"/>
                      </a:ext>
                    </a:extLst>
                  </p:cNvPr>
                  <p:cNvSpPr txBox="1"/>
                  <p:nvPr/>
                </p:nvSpPr>
                <p:spPr>
                  <a:xfrm>
                    <a:off x="2236319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17" name="テキスト ボックス 116">
                  <a:extLst>
                    <a:ext uri="{FF2B5EF4-FFF2-40B4-BE49-F238E27FC236}">
                      <a16:creationId xmlns:a16="http://schemas.microsoft.com/office/drawing/2014/main" id="{47667FD2-87AD-452C-AFAA-2D4EA5AF20B8}"/>
                    </a:ext>
                  </a:extLst>
                </p:cNvPr>
                <p:cNvSpPr txBox="1"/>
                <p:nvPr/>
              </p:nvSpPr>
              <p:spPr>
                <a:xfrm>
                  <a:off x="208791" y="5589579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DMARDs</a:t>
                  </a:r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JAKIs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9178D299-096F-4ACA-9CD3-FF1997AC2C2A}"/>
                    </a:ext>
                  </a:extLst>
                </p:cNvPr>
                <p:cNvSpPr txBox="1"/>
                <p:nvPr/>
              </p:nvSpPr>
              <p:spPr>
                <a:xfrm>
                  <a:off x="1000148" y="5218673"/>
                  <a:ext cx="4712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art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19" name="直線矢印コネクタ 118">
                  <a:extLst>
                    <a:ext uri="{FF2B5EF4-FFF2-40B4-BE49-F238E27FC236}">
                      <a16:creationId xmlns:a16="http://schemas.microsoft.com/office/drawing/2014/main" id="{60395A21-5DE8-429E-A809-F976A3B1F0E0}"/>
                    </a:ext>
                  </a:extLst>
                </p:cNvPr>
                <p:cNvCxnSpPr/>
                <p:nvPr/>
              </p:nvCxnSpPr>
              <p:spPr>
                <a:xfrm>
                  <a:off x="1191292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直線矢印コネクタ 119">
                  <a:extLst>
                    <a:ext uri="{FF2B5EF4-FFF2-40B4-BE49-F238E27FC236}">
                      <a16:creationId xmlns:a16="http://schemas.microsoft.com/office/drawing/2014/main" id="{CB2A7C83-2D41-4B68-9E72-15BA2FE78E55}"/>
                    </a:ext>
                  </a:extLst>
                </p:cNvPr>
                <p:cNvCxnSpPr/>
                <p:nvPr/>
              </p:nvCxnSpPr>
              <p:spPr>
                <a:xfrm>
                  <a:off x="2594228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1" name="テキスト ボックス 120">
                  <a:extLst>
                    <a:ext uri="{FF2B5EF4-FFF2-40B4-BE49-F238E27FC236}">
                      <a16:creationId xmlns:a16="http://schemas.microsoft.com/office/drawing/2014/main" id="{CAE01A26-053E-49A2-A160-F66E30CB9ABC}"/>
                    </a:ext>
                  </a:extLst>
                </p:cNvPr>
                <p:cNvSpPr txBox="1"/>
                <p:nvPr/>
              </p:nvSpPr>
              <p:spPr>
                <a:xfrm>
                  <a:off x="1856565" y="5189733"/>
                  <a:ext cx="147532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he last day of the exposure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正方形/長方形 121">
                  <a:extLst>
                    <a:ext uri="{FF2B5EF4-FFF2-40B4-BE49-F238E27FC236}">
                      <a16:creationId xmlns:a16="http://schemas.microsoft.com/office/drawing/2014/main" id="{20B341A8-D82C-40E5-8785-4A7324815F31}"/>
                    </a:ext>
                  </a:extLst>
                </p:cNvPr>
                <p:cNvSpPr/>
                <p:nvPr/>
              </p:nvSpPr>
              <p:spPr>
                <a:xfrm>
                  <a:off x="1198250" y="5901494"/>
                  <a:ext cx="1404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23" name="テキスト ボックス 122">
                  <a:extLst>
                    <a:ext uri="{FF2B5EF4-FFF2-40B4-BE49-F238E27FC236}">
                      <a16:creationId xmlns:a16="http://schemas.microsoft.com/office/drawing/2014/main" id="{B9223CC1-AA04-4B41-85A5-793BD7044021}"/>
                    </a:ext>
                  </a:extLst>
                </p:cNvPr>
                <p:cNvSpPr txBox="1"/>
                <p:nvPr/>
              </p:nvSpPr>
              <p:spPr>
                <a:xfrm>
                  <a:off x="208791" y="5880601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TX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13" name="矢印: 左右 112">
                <a:extLst>
                  <a:ext uri="{FF2B5EF4-FFF2-40B4-BE49-F238E27FC236}">
                    <a16:creationId xmlns:a16="http://schemas.microsoft.com/office/drawing/2014/main" id="{28091911-12DD-4FBC-884F-A0F35901AA62}"/>
                  </a:ext>
                </a:extLst>
              </p:cNvPr>
              <p:cNvSpPr/>
              <p:nvPr/>
            </p:nvSpPr>
            <p:spPr>
              <a:xfrm>
                <a:off x="4546376" y="4072598"/>
                <a:ext cx="513718" cy="230832"/>
              </a:xfrm>
              <a:prstGeom prst="left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4" name="矢印: 左右 113">
                <a:extLst>
                  <a:ext uri="{FF2B5EF4-FFF2-40B4-BE49-F238E27FC236}">
                    <a16:creationId xmlns:a16="http://schemas.microsoft.com/office/drawing/2014/main" id="{77979A83-3B96-47BA-AE93-F9682CCF1167}"/>
                  </a:ext>
                </a:extLst>
              </p:cNvPr>
              <p:cNvSpPr/>
              <p:nvPr/>
            </p:nvSpPr>
            <p:spPr>
              <a:xfrm>
                <a:off x="5086597" y="4068959"/>
                <a:ext cx="900000" cy="230832"/>
              </a:xfrm>
              <a:prstGeom prst="leftRightArrow">
                <a:avLst/>
              </a:prstGeom>
              <a:pattFill prst="lt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5F38A7FF-92B4-4821-82E6-DD9189EBA8B3}"/>
              </a:ext>
            </a:extLst>
          </p:cNvPr>
          <p:cNvGrpSpPr/>
          <p:nvPr/>
        </p:nvGrpSpPr>
        <p:grpSpPr>
          <a:xfrm>
            <a:off x="3716572" y="6526449"/>
            <a:ext cx="3276031" cy="2251303"/>
            <a:chOff x="149207" y="6480243"/>
            <a:chExt cx="3276031" cy="2251303"/>
          </a:xfrm>
        </p:grpSpPr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5BF88E4F-608C-41A6-9ABA-D398D78CBE2F}"/>
                </a:ext>
              </a:extLst>
            </p:cNvPr>
            <p:cNvSpPr txBox="1"/>
            <p:nvPr/>
          </p:nvSpPr>
          <p:spPr>
            <a:xfrm>
              <a:off x="149207" y="6480243"/>
              <a:ext cx="30321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kumimoji="1" lang="en-US" altLang="ja-JP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ceived </a:t>
              </a:r>
              <a:r>
                <a:rPr kumimoji="1" lang="en-US" altLang="ja-JP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DMARDs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JAKIs, switched to MTX 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31" name="グループ化 130">
              <a:extLst>
                <a:ext uri="{FF2B5EF4-FFF2-40B4-BE49-F238E27FC236}">
                  <a16:creationId xmlns:a16="http://schemas.microsoft.com/office/drawing/2014/main" id="{8269A634-C774-461E-90E8-00DD0042747F}"/>
                </a:ext>
              </a:extLst>
            </p:cNvPr>
            <p:cNvGrpSpPr/>
            <p:nvPr/>
          </p:nvGrpSpPr>
          <p:grpSpPr>
            <a:xfrm>
              <a:off x="250690" y="6814908"/>
              <a:ext cx="3174548" cy="1916638"/>
              <a:chOff x="3557138" y="3144329"/>
              <a:chExt cx="3174548" cy="1916638"/>
            </a:xfrm>
          </p:grpSpPr>
          <p:grpSp>
            <p:nvGrpSpPr>
              <p:cNvPr id="132" name="グループ化 131">
                <a:extLst>
                  <a:ext uri="{FF2B5EF4-FFF2-40B4-BE49-F238E27FC236}">
                    <a16:creationId xmlns:a16="http://schemas.microsoft.com/office/drawing/2014/main" id="{E31417EA-E60C-4DE0-A613-E964ED198D22}"/>
                  </a:ext>
                </a:extLst>
              </p:cNvPr>
              <p:cNvGrpSpPr/>
              <p:nvPr/>
            </p:nvGrpSpPr>
            <p:grpSpPr>
              <a:xfrm>
                <a:off x="3557138" y="3144329"/>
                <a:ext cx="3174548" cy="1916638"/>
                <a:chOff x="208791" y="5214377"/>
                <a:chExt cx="3174548" cy="1916638"/>
              </a:xfrm>
            </p:grpSpPr>
            <p:sp>
              <p:nvSpPr>
                <p:cNvPr id="135" name="正方形/長方形 134">
                  <a:extLst>
                    <a:ext uri="{FF2B5EF4-FFF2-40B4-BE49-F238E27FC236}">
                      <a16:creationId xmlns:a16="http://schemas.microsoft.com/office/drawing/2014/main" id="{C54D785D-3CB9-4CD9-97E5-1F64171142F8}"/>
                    </a:ext>
                  </a:extLst>
                </p:cNvPr>
                <p:cNvSpPr/>
                <p:nvPr/>
              </p:nvSpPr>
              <p:spPr>
                <a:xfrm>
                  <a:off x="1185140" y="5666768"/>
                  <a:ext cx="864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136" name="グループ化 135">
                  <a:extLst>
                    <a:ext uri="{FF2B5EF4-FFF2-40B4-BE49-F238E27FC236}">
                      <a16:creationId xmlns:a16="http://schemas.microsoft.com/office/drawing/2014/main" id="{2D239BFB-6D65-4FFF-A073-10BCABB4BE6B}"/>
                    </a:ext>
                  </a:extLst>
                </p:cNvPr>
                <p:cNvGrpSpPr/>
                <p:nvPr/>
              </p:nvGrpSpPr>
              <p:grpSpPr>
                <a:xfrm>
                  <a:off x="1105917" y="6644692"/>
                  <a:ext cx="2013406" cy="486323"/>
                  <a:chOff x="1095105" y="6426823"/>
                  <a:chExt cx="2013406" cy="486323"/>
                </a:xfrm>
              </p:grpSpPr>
              <p:cxnSp>
                <p:nvCxnSpPr>
                  <p:cNvPr id="144" name="直線矢印コネクタ 143">
                    <a:extLst>
                      <a:ext uri="{FF2B5EF4-FFF2-40B4-BE49-F238E27FC236}">
                        <a16:creationId xmlns:a16="http://schemas.microsoft.com/office/drawing/2014/main" id="{E6DEC863-876D-420B-8539-9CCA5BA6C783}"/>
                      </a:ext>
                    </a:extLst>
                  </p:cNvPr>
                  <p:cNvCxnSpPr/>
                  <p:nvPr/>
                </p:nvCxnSpPr>
                <p:spPr>
                  <a:xfrm>
                    <a:off x="1191292" y="6426823"/>
                    <a:ext cx="1800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5" name="テキスト ボックス 144">
                    <a:extLst>
                      <a:ext uri="{FF2B5EF4-FFF2-40B4-BE49-F238E27FC236}">
                        <a16:creationId xmlns:a16="http://schemas.microsoft.com/office/drawing/2014/main" id="{5D5EBBC8-C341-4513-A65E-1A45A3686F62}"/>
                      </a:ext>
                    </a:extLst>
                  </p:cNvPr>
                  <p:cNvSpPr txBox="1"/>
                  <p:nvPr/>
                </p:nvSpPr>
                <p:spPr>
                  <a:xfrm>
                    <a:off x="1715814" y="6682314"/>
                    <a:ext cx="104100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ime (years)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6" name="テキスト ボックス 145">
                    <a:extLst>
                      <a:ext uri="{FF2B5EF4-FFF2-40B4-BE49-F238E27FC236}">
                        <a16:creationId xmlns:a16="http://schemas.microsoft.com/office/drawing/2014/main" id="{34D453BB-3E0C-420B-A494-3DC376CD9887}"/>
                      </a:ext>
                    </a:extLst>
                  </p:cNvPr>
                  <p:cNvSpPr txBox="1"/>
                  <p:nvPr/>
                </p:nvSpPr>
                <p:spPr>
                  <a:xfrm>
                    <a:off x="1095105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7" name="テキスト ボックス 146">
                    <a:extLst>
                      <a:ext uri="{FF2B5EF4-FFF2-40B4-BE49-F238E27FC236}">
                        <a16:creationId xmlns:a16="http://schemas.microsoft.com/office/drawing/2014/main" id="{AE09E7C9-ECE6-43B4-B4EF-F779D2A3740C}"/>
                      </a:ext>
                    </a:extLst>
                  </p:cNvPr>
                  <p:cNvSpPr txBox="1"/>
                  <p:nvPr/>
                </p:nvSpPr>
                <p:spPr>
                  <a:xfrm>
                    <a:off x="2827157" y="6510104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8" name="テキスト ボックス 147">
                    <a:extLst>
                      <a:ext uri="{FF2B5EF4-FFF2-40B4-BE49-F238E27FC236}">
                        <a16:creationId xmlns:a16="http://schemas.microsoft.com/office/drawing/2014/main" id="{177D64D1-E57A-4197-9C75-E7BF34500866}"/>
                      </a:ext>
                    </a:extLst>
                  </p:cNvPr>
                  <p:cNvSpPr txBox="1"/>
                  <p:nvPr/>
                </p:nvSpPr>
                <p:spPr>
                  <a:xfrm>
                    <a:off x="1638441" y="6496861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9" name="テキスト ボックス 148">
                    <a:extLst>
                      <a:ext uri="{FF2B5EF4-FFF2-40B4-BE49-F238E27FC236}">
                        <a16:creationId xmlns:a16="http://schemas.microsoft.com/office/drawing/2014/main" id="{43074076-B9E5-4826-A986-51C6F7C6421A}"/>
                      </a:ext>
                    </a:extLst>
                  </p:cNvPr>
                  <p:cNvSpPr txBox="1"/>
                  <p:nvPr/>
                </p:nvSpPr>
                <p:spPr>
                  <a:xfrm>
                    <a:off x="2236319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37" name="テキスト ボックス 136">
                  <a:extLst>
                    <a:ext uri="{FF2B5EF4-FFF2-40B4-BE49-F238E27FC236}">
                      <a16:creationId xmlns:a16="http://schemas.microsoft.com/office/drawing/2014/main" id="{A59028D3-8DD0-481E-9212-4147332E84E1}"/>
                    </a:ext>
                  </a:extLst>
                </p:cNvPr>
                <p:cNvSpPr txBox="1"/>
                <p:nvPr/>
              </p:nvSpPr>
              <p:spPr>
                <a:xfrm>
                  <a:off x="208791" y="5589579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DMARDs</a:t>
                  </a:r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JAKIs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8" name="テキスト ボックス 137">
                  <a:extLst>
                    <a:ext uri="{FF2B5EF4-FFF2-40B4-BE49-F238E27FC236}">
                      <a16:creationId xmlns:a16="http://schemas.microsoft.com/office/drawing/2014/main" id="{7DE7F6C6-614A-4D83-932B-3387E555701C}"/>
                    </a:ext>
                  </a:extLst>
                </p:cNvPr>
                <p:cNvSpPr txBox="1"/>
                <p:nvPr/>
              </p:nvSpPr>
              <p:spPr>
                <a:xfrm>
                  <a:off x="1000148" y="5218673"/>
                  <a:ext cx="4712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art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39" name="直線矢印コネクタ 138">
                  <a:extLst>
                    <a:ext uri="{FF2B5EF4-FFF2-40B4-BE49-F238E27FC236}">
                      <a16:creationId xmlns:a16="http://schemas.microsoft.com/office/drawing/2014/main" id="{8AFF7774-B794-4AF9-874F-1AABC850DA82}"/>
                    </a:ext>
                  </a:extLst>
                </p:cNvPr>
                <p:cNvCxnSpPr/>
                <p:nvPr/>
              </p:nvCxnSpPr>
              <p:spPr>
                <a:xfrm>
                  <a:off x="1191292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直線矢印コネクタ 139">
                  <a:extLst>
                    <a:ext uri="{FF2B5EF4-FFF2-40B4-BE49-F238E27FC236}">
                      <a16:creationId xmlns:a16="http://schemas.microsoft.com/office/drawing/2014/main" id="{5AC364A2-6AFE-42F0-8394-CC1B4008AAA5}"/>
                    </a:ext>
                  </a:extLst>
                </p:cNvPr>
                <p:cNvCxnSpPr/>
                <p:nvPr/>
              </p:nvCxnSpPr>
              <p:spPr>
                <a:xfrm>
                  <a:off x="2039419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1" name="テキスト ボックス 140">
                  <a:extLst>
                    <a:ext uri="{FF2B5EF4-FFF2-40B4-BE49-F238E27FC236}">
                      <a16:creationId xmlns:a16="http://schemas.microsoft.com/office/drawing/2014/main" id="{A05EED24-642B-47DD-96E5-BC8DA27FF0BC}"/>
                    </a:ext>
                  </a:extLst>
                </p:cNvPr>
                <p:cNvSpPr txBox="1"/>
                <p:nvPr/>
              </p:nvSpPr>
              <p:spPr>
                <a:xfrm>
                  <a:off x="1798738" y="5214377"/>
                  <a:ext cx="158460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he last day of the exposure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2" name="正方形/長方形 141">
                  <a:extLst>
                    <a:ext uri="{FF2B5EF4-FFF2-40B4-BE49-F238E27FC236}">
                      <a16:creationId xmlns:a16="http://schemas.microsoft.com/office/drawing/2014/main" id="{881B059B-C20C-49BF-8AC6-A56AFA769620}"/>
                    </a:ext>
                  </a:extLst>
                </p:cNvPr>
                <p:cNvSpPr/>
                <p:nvPr/>
              </p:nvSpPr>
              <p:spPr>
                <a:xfrm>
                  <a:off x="2124386" y="5818713"/>
                  <a:ext cx="540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43" name="テキスト ボックス 142">
                  <a:extLst>
                    <a:ext uri="{FF2B5EF4-FFF2-40B4-BE49-F238E27FC236}">
                      <a16:creationId xmlns:a16="http://schemas.microsoft.com/office/drawing/2014/main" id="{CFC1CC7B-8684-4568-8320-1A35D5152ACB}"/>
                    </a:ext>
                  </a:extLst>
                </p:cNvPr>
                <p:cNvSpPr txBox="1"/>
                <p:nvPr/>
              </p:nvSpPr>
              <p:spPr>
                <a:xfrm>
                  <a:off x="208791" y="5880601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TX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34" name="矢印: 左右 133">
                <a:extLst>
                  <a:ext uri="{FF2B5EF4-FFF2-40B4-BE49-F238E27FC236}">
                    <a16:creationId xmlns:a16="http://schemas.microsoft.com/office/drawing/2014/main" id="{4FA066B1-608F-47A1-A7F4-6782C2760DDA}"/>
                  </a:ext>
                </a:extLst>
              </p:cNvPr>
              <p:cNvSpPr/>
              <p:nvPr/>
            </p:nvSpPr>
            <p:spPr>
              <a:xfrm>
                <a:off x="4521724" y="4039028"/>
                <a:ext cx="900000" cy="230832"/>
              </a:xfrm>
              <a:prstGeom prst="leftRightArrow">
                <a:avLst/>
              </a:prstGeom>
              <a:pattFill prst="lt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368001F2-1C35-42E4-861C-C5FDA54371B1}"/>
              </a:ext>
            </a:extLst>
          </p:cNvPr>
          <p:cNvGrpSpPr/>
          <p:nvPr/>
        </p:nvGrpSpPr>
        <p:grpSpPr>
          <a:xfrm>
            <a:off x="3836753" y="4321473"/>
            <a:ext cx="3104122" cy="2176787"/>
            <a:chOff x="3625562" y="6519903"/>
            <a:chExt cx="3104122" cy="2176787"/>
          </a:xfrm>
        </p:grpSpPr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3B9B63F4-D8A7-4D23-8F9F-F19D396CC3A4}"/>
                </a:ext>
              </a:extLst>
            </p:cNvPr>
            <p:cNvGrpSpPr/>
            <p:nvPr/>
          </p:nvGrpSpPr>
          <p:grpSpPr>
            <a:xfrm>
              <a:off x="3625562" y="6784348"/>
              <a:ext cx="2910532" cy="1912342"/>
              <a:chOff x="148365" y="3094861"/>
              <a:chExt cx="2910532" cy="1912342"/>
            </a:xfrm>
          </p:grpSpPr>
          <p:grpSp>
            <p:nvGrpSpPr>
              <p:cNvPr id="153" name="グループ化 152">
                <a:extLst>
                  <a:ext uri="{FF2B5EF4-FFF2-40B4-BE49-F238E27FC236}">
                    <a16:creationId xmlns:a16="http://schemas.microsoft.com/office/drawing/2014/main" id="{3C8706FE-7B73-421E-8DDB-D257472A8785}"/>
                  </a:ext>
                </a:extLst>
              </p:cNvPr>
              <p:cNvGrpSpPr/>
              <p:nvPr/>
            </p:nvGrpSpPr>
            <p:grpSpPr>
              <a:xfrm>
                <a:off x="148365" y="3094861"/>
                <a:ext cx="2910532" cy="1912342"/>
                <a:chOff x="208791" y="5218673"/>
                <a:chExt cx="2910532" cy="1912342"/>
              </a:xfrm>
            </p:grpSpPr>
            <p:sp>
              <p:nvSpPr>
                <p:cNvPr id="155" name="正方形/長方形 154">
                  <a:extLst>
                    <a:ext uri="{FF2B5EF4-FFF2-40B4-BE49-F238E27FC236}">
                      <a16:creationId xmlns:a16="http://schemas.microsoft.com/office/drawing/2014/main" id="{3AE2B65F-C477-496B-B303-54477DB48544}"/>
                    </a:ext>
                  </a:extLst>
                </p:cNvPr>
                <p:cNvSpPr/>
                <p:nvPr/>
              </p:nvSpPr>
              <p:spPr>
                <a:xfrm>
                  <a:off x="1191292" y="5666768"/>
                  <a:ext cx="1404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grpSp>
              <p:nvGrpSpPr>
                <p:cNvPr id="156" name="グループ化 155">
                  <a:extLst>
                    <a:ext uri="{FF2B5EF4-FFF2-40B4-BE49-F238E27FC236}">
                      <a16:creationId xmlns:a16="http://schemas.microsoft.com/office/drawing/2014/main" id="{284FB47C-9013-42A4-AFD6-8C503DE32BE2}"/>
                    </a:ext>
                  </a:extLst>
                </p:cNvPr>
                <p:cNvGrpSpPr/>
                <p:nvPr/>
              </p:nvGrpSpPr>
              <p:grpSpPr>
                <a:xfrm>
                  <a:off x="1105917" y="6644692"/>
                  <a:ext cx="2013406" cy="486323"/>
                  <a:chOff x="1095105" y="6426823"/>
                  <a:chExt cx="2013406" cy="486323"/>
                </a:xfrm>
              </p:grpSpPr>
              <p:cxnSp>
                <p:nvCxnSpPr>
                  <p:cNvPr id="164" name="直線矢印コネクタ 163">
                    <a:extLst>
                      <a:ext uri="{FF2B5EF4-FFF2-40B4-BE49-F238E27FC236}">
                        <a16:creationId xmlns:a16="http://schemas.microsoft.com/office/drawing/2014/main" id="{DB0EAF74-2DD0-4FBB-B069-FBF119505241}"/>
                      </a:ext>
                    </a:extLst>
                  </p:cNvPr>
                  <p:cNvCxnSpPr/>
                  <p:nvPr/>
                </p:nvCxnSpPr>
                <p:spPr>
                  <a:xfrm>
                    <a:off x="1191292" y="6426823"/>
                    <a:ext cx="1800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5" name="テキスト ボックス 164">
                    <a:extLst>
                      <a:ext uri="{FF2B5EF4-FFF2-40B4-BE49-F238E27FC236}">
                        <a16:creationId xmlns:a16="http://schemas.microsoft.com/office/drawing/2014/main" id="{D3C7A1AC-4158-40FE-8B22-CB40B1255A33}"/>
                      </a:ext>
                    </a:extLst>
                  </p:cNvPr>
                  <p:cNvSpPr txBox="1"/>
                  <p:nvPr/>
                </p:nvSpPr>
                <p:spPr>
                  <a:xfrm>
                    <a:off x="1715814" y="6682314"/>
                    <a:ext cx="104100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ime (years)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6" name="テキスト ボックス 165">
                    <a:extLst>
                      <a:ext uri="{FF2B5EF4-FFF2-40B4-BE49-F238E27FC236}">
                        <a16:creationId xmlns:a16="http://schemas.microsoft.com/office/drawing/2014/main" id="{963D5806-BB9F-4295-9A1A-448A988522A0}"/>
                      </a:ext>
                    </a:extLst>
                  </p:cNvPr>
                  <p:cNvSpPr txBox="1"/>
                  <p:nvPr/>
                </p:nvSpPr>
                <p:spPr>
                  <a:xfrm>
                    <a:off x="1095105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7" name="テキスト ボックス 166">
                    <a:extLst>
                      <a:ext uri="{FF2B5EF4-FFF2-40B4-BE49-F238E27FC236}">
                        <a16:creationId xmlns:a16="http://schemas.microsoft.com/office/drawing/2014/main" id="{C4460EBA-545C-4F87-8345-D8374C315AB7}"/>
                      </a:ext>
                    </a:extLst>
                  </p:cNvPr>
                  <p:cNvSpPr txBox="1"/>
                  <p:nvPr/>
                </p:nvSpPr>
                <p:spPr>
                  <a:xfrm>
                    <a:off x="2827157" y="6510104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8" name="テキスト ボックス 167">
                    <a:extLst>
                      <a:ext uri="{FF2B5EF4-FFF2-40B4-BE49-F238E27FC236}">
                        <a16:creationId xmlns:a16="http://schemas.microsoft.com/office/drawing/2014/main" id="{7FE88C3A-701E-4B62-928B-32D3E35B49D4}"/>
                      </a:ext>
                    </a:extLst>
                  </p:cNvPr>
                  <p:cNvSpPr txBox="1"/>
                  <p:nvPr/>
                </p:nvSpPr>
                <p:spPr>
                  <a:xfrm>
                    <a:off x="1638441" y="6496861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9" name="テキスト ボックス 168">
                    <a:extLst>
                      <a:ext uri="{FF2B5EF4-FFF2-40B4-BE49-F238E27FC236}">
                        <a16:creationId xmlns:a16="http://schemas.microsoft.com/office/drawing/2014/main" id="{9ADCCA5B-0C15-4429-AFE9-2603E0166521}"/>
                      </a:ext>
                    </a:extLst>
                  </p:cNvPr>
                  <p:cNvSpPr txBox="1"/>
                  <p:nvPr/>
                </p:nvSpPr>
                <p:spPr>
                  <a:xfrm>
                    <a:off x="2236319" y="6508815"/>
                    <a:ext cx="28135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kumimoji="1" lang="ja-JP" alt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57" name="テキスト ボックス 156">
                  <a:extLst>
                    <a:ext uri="{FF2B5EF4-FFF2-40B4-BE49-F238E27FC236}">
                      <a16:creationId xmlns:a16="http://schemas.microsoft.com/office/drawing/2014/main" id="{B0D305EF-C695-48FA-B9E5-E98D6C57DA2A}"/>
                    </a:ext>
                  </a:extLst>
                </p:cNvPr>
                <p:cNvSpPr txBox="1"/>
                <p:nvPr/>
              </p:nvSpPr>
              <p:spPr>
                <a:xfrm>
                  <a:off x="208791" y="5589579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DMARDs</a:t>
                  </a:r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JAKIs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" name="テキスト ボックス 157">
                  <a:extLst>
                    <a:ext uri="{FF2B5EF4-FFF2-40B4-BE49-F238E27FC236}">
                      <a16:creationId xmlns:a16="http://schemas.microsoft.com/office/drawing/2014/main" id="{C5364B82-B7C3-4EAF-B436-814BFF334659}"/>
                    </a:ext>
                  </a:extLst>
                </p:cNvPr>
                <p:cNvSpPr txBox="1"/>
                <p:nvPr/>
              </p:nvSpPr>
              <p:spPr>
                <a:xfrm>
                  <a:off x="1000148" y="5218673"/>
                  <a:ext cx="4712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art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59" name="直線矢印コネクタ 158">
                  <a:extLst>
                    <a:ext uri="{FF2B5EF4-FFF2-40B4-BE49-F238E27FC236}">
                      <a16:creationId xmlns:a16="http://schemas.microsoft.com/office/drawing/2014/main" id="{E44AC0DA-1D9C-44D1-812E-7E9EA50E1F46}"/>
                    </a:ext>
                  </a:extLst>
                </p:cNvPr>
                <p:cNvCxnSpPr/>
                <p:nvPr/>
              </p:nvCxnSpPr>
              <p:spPr>
                <a:xfrm>
                  <a:off x="1191292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0" name="直線矢印コネクタ 159">
                  <a:extLst>
                    <a:ext uri="{FF2B5EF4-FFF2-40B4-BE49-F238E27FC236}">
                      <a16:creationId xmlns:a16="http://schemas.microsoft.com/office/drawing/2014/main" id="{AB70B3E0-6AFA-4881-A8F7-7D020B1EEF8A}"/>
                    </a:ext>
                  </a:extLst>
                </p:cNvPr>
                <p:cNvCxnSpPr/>
                <p:nvPr/>
              </p:nvCxnSpPr>
              <p:spPr>
                <a:xfrm>
                  <a:off x="2583954" y="5409579"/>
                  <a:ext cx="0" cy="180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986F5FD7-A009-448B-80D1-3621C9718DBF}"/>
                    </a:ext>
                  </a:extLst>
                </p:cNvPr>
                <p:cNvSpPr txBox="1"/>
                <p:nvPr/>
              </p:nvSpPr>
              <p:spPr>
                <a:xfrm>
                  <a:off x="1403827" y="5222837"/>
                  <a:ext cx="147532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he last day of the exposure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2" name="正方形/長方形 161">
                  <a:extLst>
                    <a:ext uri="{FF2B5EF4-FFF2-40B4-BE49-F238E27FC236}">
                      <a16:creationId xmlns:a16="http://schemas.microsoft.com/office/drawing/2014/main" id="{1C21F2FB-DD14-478D-943B-252BFBA4E037}"/>
                    </a:ext>
                  </a:extLst>
                </p:cNvPr>
                <p:cNvSpPr/>
                <p:nvPr/>
              </p:nvSpPr>
              <p:spPr>
                <a:xfrm>
                  <a:off x="1948261" y="5901494"/>
                  <a:ext cx="648000" cy="146795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63" name="テキスト ボックス 162">
                  <a:extLst>
                    <a:ext uri="{FF2B5EF4-FFF2-40B4-BE49-F238E27FC236}">
                      <a16:creationId xmlns:a16="http://schemas.microsoft.com/office/drawing/2014/main" id="{F7ADC3A2-652A-4420-8A63-A6C709BE196E}"/>
                    </a:ext>
                  </a:extLst>
                </p:cNvPr>
                <p:cNvSpPr txBox="1"/>
                <p:nvPr/>
              </p:nvSpPr>
              <p:spPr>
                <a:xfrm>
                  <a:off x="208791" y="5880601"/>
                  <a:ext cx="1104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TX</a:t>
                  </a:r>
                  <a:endParaRPr kumimoji="1" lang="ja-JP" alt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54" name="矢印: 左右 153">
                <a:extLst>
                  <a:ext uri="{FF2B5EF4-FFF2-40B4-BE49-F238E27FC236}">
                    <a16:creationId xmlns:a16="http://schemas.microsoft.com/office/drawing/2014/main" id="{FF297A87-910D-4986-A156-06D9A25BD01E}"/>
                  </a:ext>
                </a:extLst>
              </p:cNvPr>
              <p:cNvSpPr/>
              <p:nvPr/>
            </p:nvSpPr>
            <p:spPr>
              <a:xfrm>
                <a:off x="1101155" y="4041385"/>
                <a:ext cx="1440000" cy="206870"/>
              </a:xfrm>
              <a:prstGeom prst="leftRightArrow">
                <a:avLst/>
              </a:prstGeom>
              <a:pattFill prst="ltVert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9A216167-E06B-4957-A667-ECCEF338D0FA}"/>
                </a:ext>
              </a:extLst>
            </p:cNvPr>
            <p:cNvSpPr txBox="1"/>
            <p:nvPr/>
          </p:nvSpPr>
          <p:spPr>
            <a:xfrm>
              <a:off x="3697546" y="6519903"/>
              <a:ext cx="30321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) Received </a:t>
              </a:r>
              <a:r>
                <a:rPr kumimoji="1" lang="en-US" altLang="ja-JP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DMARDs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JAKIs,  added MTX 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83867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98324" y="3770194"/>
            <a:ext cx="1395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62682" y="465293"/>
            <a:ext cx="8176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groups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67625" y="3291560"/>
            <a:ext cx="40346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dds ratio of </a:t>
            </a:r>
            <a:r>
              <a:rPr lang="en-US" altLang="ja-JP" sz="900">
                <a:latin typeface="Times New Roman" panose="02020603050405020304" pitchFamily="18" charset="0"/>
                <a:cs typeface="Times New Roman" panose="02020603050405020304" pitchFamily="18" charset="0"/>
              </a:rPr>
              <a:t>bDMARDs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sus MTX for hospitalized infection</a:t>
            </a:r>
            <a:endParaRPr lang="ja-JP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グループ化 13"/>
          <p:cNvGrpSpPr/>
          <p:nvPr/>
        </p:nvGrpSpPr>
        <p:grpSpPr>
          <a:xfrm>
            <a:off x="740272" y="609601"/>
            <a:ext cx="3209428" cy="2567632"/>
            <a:chOff x="740272" y="609601"/>
            <a:chExt cx="3209428" cy="2567632"/>
          </a:xfrm>
        </p:grpSpPr>
        <p:pic>
          <p:nvPicPr>
            <p:cNvPr id="6" name="図 5"/>
            <p:cNvPicPr/>
            <p:nvPr/>
          </p:nvPicPr>
          <p:blipFill rotWithShape="1">
            <a:blip r:embed="rId2"/>
            <a:srcRect l="7790" b="10529"/>
            <a:stretch/>
          </p:blipFill>
          <p:spPr bwMode="auto">
            <a:xfrm>
              <a:off x="1180367" y="609601"/>
              <a:ext cx="2769333" cy="234950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7" name="テキスト ボックス 6"/>
            <p:cNvSpPr txBox="1"/>
            <p:nvPr/>
          </p:nvSpPr>
          <p:spPr>
            <a:xfrm>
              <a:off x="806458" y="986912"/>
              <a:ext cx="6975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-</a:t>
              </a:r>
              <a:endParaRPr kumimoji="1" lang="ja-JP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740272" y="1670801"/>
              <a:ext cx="6975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5-74</a:t>
              </a:r>
              <a:endParaRPr kumimoji="1" lang="ja-JP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740273" y="2349508"/>
              <a:ext cx="6975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-64</a:t>
              </a:r>
              <a:endParaRPr kumimoji="1" lang="ja-JP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947985" y="2945006"/>
              <a:ext cx="40640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1" lang="ja-JP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584929" y="2946401"/>
              <a:ext cx="40640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1" lang="ja-JP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3070464" y="2944205"/>
              <a:ext cx="40640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1" lang="ja-JP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476864" y="2938656"/>
              <a:ext cx="40640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kumimoji="1" lang="ja-JP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B84C624-8D11-453F-96E9-AD7C7C3464DC}"/>
              </a:ext>
            </a:extLst>
          </p:cNvPr>
          <p:cNvSpPr txBox="1"/>
          <p:nvPr/>
        </p:nvSpPr>
        <p:spPr>
          <a:xfrm>
            <a:off x="2136076" y="748270"/>
            <a:ext cx="590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99BB17D-9DAF-4426-BD76-906D304F2C28}"/>
              </a:ext>
            </a:extLst>
          </p:cNvPr>
          <p:cNvSpPr txBox="1"/>
          <p:nvPr/>
        </p:nvSpPr>
        <p:spPr>
          <a:xfrm>
            <a:off x="2269650" y="1440937"/>
            <a:ext cx="590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A8422E0-8B80-4332-A702-A467914407C1}"/>
              </a:ext>
            </a:extLst>
          </p:cNvPr>
          <p:cNvSpPr txBox="1"/>
          <p:nvPr/>
        </p:nvSpPr>
        <p:spPr>
          <a:xfrm>
            <a:off x="2860415" y="2152157"/>
            <a:ext cx="590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1.3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3619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9DA5EACA56D5B342BFF9D1DE01734887" ma:contentTypeVersion="2" ma:contentTypeDescription="新しいドキュメントを作成します。" ma:contentTypeScope="" ma:versionID="fe0b96484108ab239efd3b6f7366cb3e">
  <xsd:schema xmlns:xsd="http://www.w3.org/2001/XMLSchema" xmlns:xs="http://www.w3.org/2001/XMLSchema" xmlns:p="http://schemas.microsoft.com/office/2006/metadata/properties" xmlns:ns3="1f6b9f26-1925-401d-a9d1-cbb7323eea09" targetNamespace="http://schemas.microsoft.com/office/2006/metadata/properties" ma:root="true" ma:fieldsID="9b0047dd4d81436b02bfcde51f439a5e" ns3:_="">
    <xsd:import namespace="1f6b9f26-1925-401d-a9d1-cbb7323eea0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6b9f26-1925-401d-a9d1-cbb7323eea0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28E4C849-14A4-4170-820D-A0208E351AC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6b9f26-1925-401d-a9d1-cbb7323eea0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18385E5-CE6D-4120-98EC-608C41F809D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6FA7D88-B6E5-4547-9FCF-F297CBC7F4A2}">
  <ds:schemaRefs>
    <ds:schemaRef ds:uri="1f6b9f26-1925-401d-a9d1-cbb7323eea09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5</TotalTime>
  <Words>265</Words>
  <Application>Microsoft Office PowerPoint</Application>
  <PresentationFormat>画面に合わせる (4:3)</PresentationFormat>
  <Paragraphs>9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酒井 良子</dc:creator>
  <cp:lastModifiedBy>酒井　良子</cp:lastModifiedBy>
  <cp:revision>42</cp:revision>
  <dcterms:created xsi:type="dcterms:W3CDTF">2020-12-23T07:03:40Z</dcterms:created>
  <dcterms:modified xsi:type="dcterms:W3CDTF">2021-10-27T09:06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A5EACA56D5B342BFF9D1DE01734887</vt:lpwstr>
  </property>
</Properties>
</file>